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02" autoAdjust="0"/>
    <p:restoredTop sz="94660"/>
  </p:normalViewPr>
  <p:slideViewPr>
    <p:cSldViewPr snapToGrid="0">
      <p:cViewPr varScale="1">
        <p:scale>
          <a:sx n="99" d="100"/>
          <a:sy n="99" d="100"/>
        </p:scale>
        <p:origin x="96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19Dez19%20Backup%20Marlies\AA%20AA%20MS%20in%20Process_Antr&#228;ge%20and%20Reveiws%202015\04_2020%20COVID-19%20Letter\aa%20MS%20and%20Figures\Covid-19%20Rapid%20Test_Labparameters%20&#214;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19Dez19%20Backup%20Marlies\AA%20AA%20MS%20in%20Process_Antr&#228;ge%20and%20Reveiws%202015\04_2020%20COVID-19%20Letter\aa%20MS%20and%20Figures\Neu%20Covid-19%20Rapid%20Test_Labparameters%20&#214;G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19Dez19%20Backup%20Marlies\AA%20AA%20MS%20in%20Process_Antr&#228;ge%20and%20Reveiws%202015\04_2020%20COVID-19%20Letter\aa%20MS%20and%20Figures\Covid-19%20Rapid%20Test_Labparameters%20&#214;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7328152777777771"/>
          <c:y val="7.0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Labor!$J$6</c:f>
              <c:strCache>
                <c:ptCount val="1"/>
                <c:pt idx="0">
                  <c:v>CR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Labor!$I$7:$I$17</c:f>
              <c:strCache>
                <c:ptCount val="11"/>
                <c:pt idx="0">
                  <c:v>02.03.</c:v>
                </c:pt>
                <c:pt idx="1">
                  <c:v>06.03.</c:v>
                </c:pt>
                <c:pt idx="2">
                  <c:v>09.03.</c:v>
                </c:pt>
                <c:pt idx="3">
                  <c:v>10.03.</c:v>
                </c:pt>
                <c:pt idx="4">
                  <c:v>13.03.</c:v>
                </c:pt>
                <c:pt idx="5">
                  <c:v>14.03.</c:v>
                </c:pt>
                <c:pt idx="6">
                  <c:v>18.03.</c:v>
                </c:pt>
                <c:pt idx="7">
                  <c:v>19.03.</c:v>
                </c:pt>
                <c:pt idx="8">
                  <c:v>20.03.</c:v>
                </c:pt>
                <c:pt idx="9">
                  <c:v>21.03.</c:v>
                </c:pt>
                <c:pt idx="10">
                  <c:v>24.03.</c:v>
                </c:pt>
              </c:strCache>
            </c:strRef>
          </c:cat>
          <c:val>
            <c:numRef>
              <c:f>Labor!$J$7:$J$17</c:f>
              <c:numCache>
                <c:formatCode>General</c:formatCode>
                <c:ptCount val="11"/>
                <c:pt idx="0">
                  <c:v>0.1</c:v>
                </c:pt>
                <c:pt idx="1">
                  <c:v>0.9</c:v>
                </c:pt>
                <c:pt idx="2">
                  <c:v>3.2</c:v>
                </c:pt>
                <c:pt idx="3">
                  <c:v>6.4</c:v>
                </c:pt>
                <c:pt idx="4">
                  <c:v>32.5</c:v>
                </c:pt>
                <c:pt idx="5">
                  <c:v>42.7</c:v>
                </c:pt>
                <c:pt idx="6">
                  <c:v>35.9</c:v>
                </c:pt>
                <c:pt idx="7">
                  <c:v>34.4</c:v>
                </c:pt>
                <c:pt idx="8">
                  <c:v>40.299999999999997</c:v>
                </c:pt>
                <c:pt idx="9">
                  <c:v>42.6</c:v>
                </c:pt>
                <c:pt idx="10">
                  <c:v>32.7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6F1-440D-99B4-DCF10CB99A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519184"/>
        <c:axId val="136040528"/>
      </c:lineChart>
      <c:catAx>
        <c:axId val="92519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36040528"/>
        <c:crosses val="autoZero"/>
        <c:auto val="1"/>
        <c:lblAlgn val="ctr"/>
        <c:lblOffset val="100"/>
        <c:noMultiLvlLbl val="0"/>
      </c:catAx>
      <c:valAx>
        <c:axId val="136040528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2519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7246125"/>
          <c:y val="7.0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Labor!$N$6</c:f>
              <c:strCache>
                <c:ptCount val="1"/>
                <c:pt idx="0">
                  <c:v>LDH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Labor!$M$7:$M$16</c:f>
              <c:strCache>
                <c:ptCount val="10"/>
                <c:pt idx="0">
                  <c:v>02.03.</c:v>
                </c:pt>
                <c:pt idx="1">
                  <c:v>06.03.</c:v>
                </c:pt>
                <c:pt idx="2">
                  <c:v>09.03.</c:v>
                </c:pt>
                <c:pt idx="3">
                  <c:v>10.03.</c:v>
                </c:pt>
                <c:pt idx="4">
                  <c:v>13.03.</c:v>
                </c:pt>
                <c:pt idx="5">
                  <c:v>14.03.</c:v>
                </c:pt>
                <c:pt idx="6">
                  <c:v>18.03.</c:v>
                </c:pt>
                <c:pt idx="7">
                  <c:v>19.03.</c:v>
                </c:pt>
                <c:pt idx="8">
                  <c:v>20.03.</c:v>
                </c:pt>
                <c:pt idx="9">
                  <c:v>21.03.</c:v>
                </c:pt>
              </c:strCache>
            </c:strRef>
          </c:cat>
          <c:val>
            <c:numRef>
              <c:f>Labor!$N$7:$N$16</c:f>
              <c:numCache>
                <c:formatCode>General</c:formatCode>
                <c:ptCount val="10"/>
                <c:pt idx="0">
                  <c:v>242</c:v>
                </c:pt>
                <c:pt idx="1">
                  <c:v>229</c:v>
                </c:pt>
                <c:pt idx="2">
                  <c:v>272</c:v>
                </c:pt>
                <c:pt idx="3">
                  <c:v>285</c:v>
                </c:pt>
                <c:pt idx="4">
                  <c:v>289</c:v>
                </c:pt>
                <c:pt idx="5">
                  <c:v>368</c:v>
                </c:pt>
                <c:pt idx="6">
                  <c:v>477</c:v>
                </c:pt>
                <c:pt idx="7">
                  <c:v>419</c:v>
                </c:pt>
                <c:pt idx="8">
                  <c:v>411</c:v>
                </c:pt>
                <c:pt idx="9">
                  <c:v>4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55B-407F-A259-131A4FE9FC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845712"/>
        <c:axId val="92782440"/>
      </c:lineChart>
      <c:catAx>
        <c:axId val="92845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2782440"/>
        <c:crosses val="autoZero"/>
        <c:auto val="1"/>
        <c:lblAlgn val="ctr"/>
        <c:lblOffset val="100"/>
        <c:noMultiLvlLbl val="0"/>
      </c:catAx>
      <c:valAx>
        <c:axId val="92782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2845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eukocytes</a:t>
            </a:r>
          </a:p>
        </c:rich>
      </c:tx>
      <c:layout>
        <c:manualLayout>
          <c:xMode val="edge"/>
          <c:yMode val="edge"/>
          <c:x val="0.44228156565656568"/>
          <c:y val="6.467592592592592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cked"/>
        <c:varyColors val="0"/>
        <c:ser>
          <c:idx val="0"/>
          <c:order val="0"/>
          <c:tx>
            <c:strRef>
              <c:f>Labor!$C$4</c:f>
              <c:strCache>
                <c:ptCount val="1"/>
                <c:pt idx="0">
                  <c:v>Leukocytes 10e3/µ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Labor!$B$5:$B$18</c:f>
              <c:strCache>
                <c:ptCount val="14"/>
                <c:pt idx="0">
                  <c:v>02.03.</c:v>
                </c:pt>
                <c:pt idx="1">
                  <c:v>06.03.</c:v>
                </c:pt>
                <c:pt idx="2">
                  <c:v>09.03.</c:v>
                </c:pt>
                <c:pt idx="3">
                  <c:v>10.03.</c:v>
                </c:pt>
                <c:pt idx="4">
                  <c:v>13.03.</c:v>
                </c:pt>
                <c:pt idx="5">
                  <c:v>14.03.</c:v>
                </c:pt>
                <c:pt idx="6">
                  <c:v>18.03.</c:v>
                </c:pt>
                <c:pt idx="7">
                  <c:v>19.03.</c:v>
                </c:pt>
                <c:pt idx="8">
                  <c:v>20.03.</c:v>
                </c:pt>
                <c:pt idx="9">
                  <c:v>21.03.</c:v>
                </c:pt>
                <c:pt idx="10">
                  <c:v>21.03.</c:v>
                </c:pt>
                <c:pt idx="11">
                  <c:v>22.03.</c:v>
                </c:pt>
                <c:pt idx="12">
                  <c:v>23.03.</c:v>
                </c:pt>
                <c:pt idx="13">
                  <c:v>24.03.</c:v>
                </c:pt>
              </c:strCache>
            </c:strRef>
          </c:cat>
          <c:val>
            <c:numRef>
              <c:f>Labor!$C$5:$C$18</c:f>
              <c:numCache>
                <c:formatCode>General</c:formatCode>
                <c:ptCount val="14"/>
                <c:pt idx="0">
                  <c:v>1.51</c:v>
                </c:pt>
                <c:pt idx="1">
                  <c:v>1.85</c:v>
                </c:pt>
                <c:pt idx="2">
                  <c:v>0.66</c:v>
                </c:pt>
                <c:pt idx="3">
                  <c:v>0.57999999999999996</c:v>
                </c:pt>
                <c:pt idx="4">
                  <c:v>0.06</c:v>
                </c:pt>
                <c:pt idx="5">
                  <c:v>0.05</c:v>
                </c:pt>
                <c:pt idx="6">
                  <c:v>0.05</c:v>
                </c:pt>
                <c:pt idx="7">
                  <c:v>0.02</c:v>
                </c:pt>
                <c:pt idx="8">
                  <c:v>1.08</c:v>
                </c:pt>
                <c:pt idx="9">
                  <c:v>0.26</c:v>
                </c:pt>
                <c:pt idx="10">
                  <c:v>0.09</c:v>
                </c:pt>
                <c:pt idx="11">
                  <c:v>0.1</c:v>
                </c:pt>
                <c:pt idx="12">
                  <c:v>0.08</c:v>
                </c:pt>
                <c:pt idx="13">
                  <c:v>0.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588-4C35-8025-F47A448A30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824408"/>
        <c:axId val="92824792"/>
      </c:lineChart>
      <c:catAx>
        <c:axId val="92824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2824792"/>
        <c:crosses val="autoZero"/>
        <c:auto val="1"/>
        <c:lblAlgn val="ctr"/>
        <c:lblOffset val="100"/>
        <c:noMultiLvlLbl val="0"/>
      </c:catAx>
      <c:valAx>
        <c:axId val="92824792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282440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54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4041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6993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043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9022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677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924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4059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7230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8799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53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94B94-0874-438C-84FF-2337F8F8F97D}" type="datetimeFigureOut">
              <a:rPr lang="de-DE" smtClean="0"/>
              <a:t>09.11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378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9106613" y="730233"/>
            <a:ext cx="183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Normal values</a:t>
            </a:r>
          </a:p>
        </p:txBody>
      </p:sp>
      <p:sp>
        <p:nvSpPr>
          <p:cNvPr id="17" name="Rechteck 16"/>
          <p:cNvSpPr/>
          <p:nvPr/>
        </p:nvSpPr>
        <p:spPr>
          <a:xfrm>
            <a:off x="8746613" y="814733"/>
            <a:ext cx="360000" cy="108000"/>
          </a:xfrm>
          <a:prstGeom prst="rect">
            <a:avLst/>
          </a:prstGeom>
          <a:pattFill prst="wdUpDiag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5" name="Gruppieren 4"/>
          <p:cNvGrpSpPr/>
          <p:nvPr/>
        </p:nvGrpSpPr>
        <p:grpSpPr>
          <a:xfrm>
            <a:off x="853636" y="2696070"/>
            <a:ext cx="7551368" cy="2160000"/>
            <a:chOff x="832120" y="2404758"/>
            <a:chExt cx="7551368" cy="2160000"/>
          </a:xfrm>
        </p:grpSpPr>
        <p:sp>
          <p:nvSpPr>
            <p:cNvPr id="12" name="Rechteck 11"/>
            <p:cNvSpPr/>
            <p:nvPr/>
          </p:nvSpPr>
          <p:spPr>
            <a:xfrm>
              <a:off x="1503335" y="4222086"/>
              <a:ext cx="6732000" cy="28800"/>
            </a:xfrm>
            <a:prstGeom prst="rect">
              <a:avLst/>
            </a:prstGeom>
            <a:pattFill prst="wdUpDiag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11" name="Diagramm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0090443"/>
                </p:ext>
              </p:extLst>
            </p:nvPr>
          </p:nvGraphicFramePr>
          <p:xfrm>
            <a:off x="1183488" y="2404758"/>
            <a:ext cx="720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3" name="Rectangle 86"/>
            <p:cNvSpPr>
              <a:spLocks noChangeArrowheads="1"/>
            </p:cNvSpPr>
            <p:nvPr/>
          </p:nvSpPr>
          <p:spPr bwMode="auto">
            <a:xfrm rot="16200000">
              <a:off x="299896" y="3354574"/>
              <a:ext cx="1440000" cy="375552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mg </a:t>
              </a:r>
              <a:r>
                <a:rPr kumimoji="0" lang="de-DE" altLang="de-DE" sz="14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/ dl</a:t>
              </a:r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824448" y="4772310"/>
            <a:ext cx="7526688" cy="2160000"/>
            <a:chOff x="878238" y="4553826"/>
            <a:chExt cx="7526688" cy="2160000"/>
          </a:xfrm>
        </p:grpSpPr>
        <p:sp>
          <p:nvSpPr>
            <p:cNvPr id="14" name="Rechteck 13"/>
            <p:cNvSpPr/>
            <p:nvPr/>
          </p:nvSpPr>
          <p:spPr>
            <a:xfrm>
              <a:off x="1568271" y="5886082"/>
              <a:ext cx="6732000" cy="245394"/>
            </a:xfrm>
            <a:prstGeom prst="rect">
              <a:avLst/>
            </a:prstGeom>
            <a:pattFill prst="wdUpDiag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18" name="Diagramm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9124020"/>
                </p:ext>
              </p:extLst>
            </p:nvPr>
          </p:nvGraphicFramePr>
          <p:xfrm>
            <a:off x="1204926" y="4553826"/>
            <a:ext cx="720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4" name="Rectangle 86"/>
            <p:cNvSpPr>
              <a:spLocks noChangeArrowheads="1"/>
            </p:cNvSpPr>
            <p:nvPr/>
          </p:nvSpPr>
          <p:spPr bwMode="auto">
            <a:xfrm rot="16200000">
              <a:off x="365987" y="5477779"/>
              <a:ext cx="1440000" cy="415498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Units / l</a:t>
              </a:r>
            </a:p>
          </p:txBody>
        </p:sp>
      </p:grpSp>
      <p:grpSp>
        <p:nvGrpSpPr>
          <p:cNvPr id="6" name="Gruppieren 5"/>
          <p:cNvGrpSpPr/>
          <p:nvPr/>
        </p:nvGrpSpPr>
        <p:grpSpPr>
          <a:xfrm>
            <a:off x="788902" y="578685"/>
            <a:ext cx="7622917" cy="2160000"/>
            <a:chOff x="788902" y="198361"/>
            <a:chExt cx="7622917" cy="2160000"/>
          </a:xfrm>
        </p:grpSpPr>
        <p:sp>
          <p:nvSpPr>
            <p:cNvPr id="10" name="Rechteck 9"/>
            <p:cNvSpPr/>
            <p:nvPr/>
          </p:nvSpPr>
          <p:spPr>
            <a:xfrm>
              <a:off x="1553643" y="665178"/>
              <a:ext cx="6732000" cy="684000"/>
            </a:xfrm>
            <a:prstGeom prst="rect">
              <a:avLst/>
            </a:prstGeom>
            <a:pattFill prst="wdUpDiag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8" name="Diagram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41239899"/>
                </p:ext>
              </p:extLst>
            </p:nvPr>
          </p:nvGraphicFramePr>
          <p:xfrm>
            <a:off x="1283819" y="198361"/>
            <a:ext cx="7128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5" name="Rectangle 86"/>
            <p:cNvSpPr>
              <a:spLocks noChangeArrowheads="1"/>
            </p:cNvSpPr>
            <p:nvPr/>
          </p:nvSpPr>
          <p:spPr bwMode="auto">
            <a:xfrm rot="16200000">
              <a:off x="276651" y="1139159"/>
              <a:ext cx="1440000" cy="415498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alt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0e3 </a:t>
              </a:r>
              <a:r>
                <a:rPr kumimoji="0" lang="de-DE" altLang="de-DE" sz="14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/ µl</a:t>
              </a:r>
            </a:p>
          </p:txBody>
        </p:sp>
      </p:grpSp>
      <p:sp>
        <p:nvSpPr>
          <p:cNvPr id="19" name="Textfeld 3"/>
          <p:cNvSpPr txBox="1">
            <a:spLocks noChangeArrowheads="1"/>
          </p:cNvSpPr>
          <p:nvPr/>
        </p:nvSpPr>
        <p:spPr bwMode="auto">
          <a:xfrm>
            <a:off x="85331" y="29244"/>
            <a:ext cx="11777593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Laboratory parameters including leukocytes, c-reactive protein (CRP) and lactate dehydrogenase (LDH)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t time-point of diagnosis of AML patient had a pancytopenia and leukocytes stayed low and without signs of regeneration after induction chemotherapy. CRP level increased due to the infection and CRP level persisted at a high level and also LDH increased due to the infection of the lung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3940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Breitbild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Universitätsklinikum Ul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lies Götz</dc:creator>
  <cp:lastModifiedBy>Greiner</cp:lastModifiedBy>
  <cp:revision>158</cp:revision>
  <cp:lastPrinted>2020-04-28T12:01:04Z</cp:lastPrinted>
  <dcterms:created xsi:type="dcterms:W3CDTF">2020-04-16T08:31:58Z</dcterms:created>
  <dcterms:modified xsi:type="dcterms:W3CDTF">2020-11-09T08:38:36Z</dcterms:modified>
</cp:coreProperties>
</file>